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Appendix 1. Search process" id="{481DFE21-4F18-46CD-AF5F-9C8929E09745}">
          <p14:sldIdLst>
            <p14:sldId id="263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ddels stil 2 – uthev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Ingen stil, ingen rutenett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Ingen stil, tabellrutenett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113A9D2-9D6B-4929-AA2D-F23B5EE8CBE7}" styleName="Temastil 2 – utheving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18603FDC-E32A-4AB5-989C-0864C3EAD2B8}" styleName="Temastil 2 – utheving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C2FFA5D-87B4-456A-9821-1D502468CF0F}" styleName="Temastil 1 – utheving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3B4B98B0-60AC-42C2-AFA5-B58CD77FA1E5}" styleName="Lys stil 1 – utheving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ys stil 1 – utheving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ys stil 1 – utheving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1FECB4D8-DB02-4DC6-A0A2-4F2EBAE1DC90}" styleName="Middels stil 1 – utheving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793D81CF-94F2-401A-BA57-92F5A7B2D0C5}" styleName="Middels stil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301B821-A1FF-4177-AEE7-76D212191A09}" styleName="Middels stil 1 – utheving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DCAF9ED-07DC-4A11-8D7F-57B35C25682E}" styleName="Middels stil 1 – utheving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27"/>
    <p:restoredTop sz="94592"/>
  </p:normalViewPr>
  <p:slideViewPr>
    <p:cSldViewPr snapToGrid="0" snapToObjects="1">
      <p:cViewPr varScale="1">
        <p:scale>
          <a:sx n="71" d="100"/>
          <a:sy n="71" d="100"/>
        </p:scale>
        <p:origin x="488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op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0D5327-5166-3143-93EC-51C3813FCCEA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4" name="Plassholder for lysbil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Plassholder for nota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D5F36D-B97E-3F43-9A95-BC341323A06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638060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0D1A0A58-E44B-8445-A786-B536D6CB7D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6E5C5750-972D-BF4B-AF0A-73B7ACC1DD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033E887E-E49B-984E-B22C-47EF99A18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618DC73F-B198-E741-82AA-0F66D5F41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227FA698-6839-474C-AC86-4B1C50CA5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58320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6132E046-379C-B147-9760-8D77C26452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0133906C-DE34-2141-9EE7-57C8A97B78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6A8EB457-4538-C747-A906-B99B7A10D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125DD8DF-7861-8642-8C7E-51F5DA79B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105A1031-275A-9F47-9BFE-86FE026EEC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23960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AFC8F2B9-2E01-0740-8FFB-3FFD81D367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8F60E19F-1A7B-3743-B5C0-A221908C04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88A93800-CD0B-2942-821B-0E94CE0A3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7EC3CEA4-C89A-B044-8DE7-C398AB1ED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25A6E7A5-DF8B-8C4E-AA7B-5E06CD6BD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858011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2DF578F-7DD0-1742-BAC8-7E4E3B1518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A4C34EA9-CA04-6D4E-884C-F28F371D7E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D1CC70E9-0D38-EF45-9EB2-7D7366736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199037E7-00A3-9F48-806B-F7DEBD577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9F328FEB-D989-9143-98B2-703795A8D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9201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EC1A5738-76D4-D144-B312-2629E22218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8F8B7B67-39EC-0C47-8E96-148183595C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A6B57B14-1D45-124D-88FB-6120F09AD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1757EA7B-7832-1F4F-BA89-C19FF08BB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1BA08427-CE99-6249-B94B-DCFEA4E30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429515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98661A56-2955-D64A-BA06-A9181B45A6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03E6D53B-5716-3546-AE48-DB96496178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2787D607-7B9F-FD41-BB08-B017EE107C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63C7CF81-1BC0-8741-8CA8-FF451AB57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D118FC25-C779-4C49-BED8-6963154E2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401E9E6F-A8B6-FC4E-BD38-0EE2A5A2E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65498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7F629A2-B883-4046-8A58-1A750C460A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2D3EE606-F511-F24F-B9F3-F07A02CCC5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4623693A-3752-0C40-89E1-B107E5DB36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3492172E-C56F-324E-BEE0-DC443B447D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E7CA7E0A-AD57-0E48-9205-3703DDA10F6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29A8E97C-11D5-B74C-86FE-8F54195DD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74FEE4E4-C2BB-5049-B8E9-4087C8219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50AA23C6-3EA8-6040-BE6C-586742BD3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59223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93FD043A-C6D4-D34E-8518-25942FF36A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6DD77B33-8441-AE46-A0A2-7AA20666B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2DC48CA8-F937-5B44-9E27-41CAE7C12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834BE38D-9C7B-AA44-B976-1481ECE676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05102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FA3836B9-024D-5845-AF82-339A5D7D3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4D089578-4DC7-144F-8081-97106A23B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F2B26FFD-FBB7-8B4C-B7E0-CB2FAE299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53847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B25CA6B-1100-164F-B049-61F7B8F87B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FFF941D1-8652-2B41-AE0C-B97C76D44B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AC5D98F9-B0C1-7F41-8E90-1BF9BD47D0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77E39EA7-11AC-BA48-AC2F-B8873B2B2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C83B8A0D-B45B-2649-A4AF-2327F97CB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E3D104FC-3336-CC4D-ACBD-1780CEC8B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57155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5B2DD15C-8CB6-4D46-A2D6-BD16346D89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6C1FBD0B-9836-834D-AD4A-AA36BE03C1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E52DD568-E669-C144-A5E8-A0D9F3F3EE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2FA3C1D0-51C4-2C40-A68D-D6E26FDE3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192B21A5-837B-C840-9BBB-4431F8A26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2818FC3D-6FD8-A44C-820E-28C346A87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30520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B68484F3-C8FC-E04A-87EE-F3FB54463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0D476D54-BD8E-1B41-A78C-FC4C89D2F1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D917DD96-88DD-A34E-8B79-42BC8D84A0C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7737CE-705B-024F-A4B6-336BBD2B64FE}" type="datetimeFigureOut">
              <a:rPr lang="nb-NO" smtClean="0"/>
              <a:t>11.10.2020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ECEE1639-0182-6B49-9B09-4EF0B14359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1C7A0D0D-4C2C-134D-9AE6-0DAAD8712B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0A450-4D03-5A49-8C37-8A1D65A07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58946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 3">
            <a:extLst>
              <a:ext uri="{FF2B5EF4-FFF2-40B4-BE49-F238E27FC236}">
                <a16:creationId xmlns:a16="http://schemas.microsoft.com/office/drawing/2014/main" id="{4FCE224F-E59D-49A0-81B1-F7B86174B9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592798"/>
              </p:ext>
            </p:extLst>
          </p:nvPr>
        </p:nvGraphicFramePr>
        <p:xfrm>
          <a:off x="838200" y="0"/>
          <a:ext cx="10905162" cy="6626828"/>
        </p:xfrm>
        <a:graphic>
          <a:graphicData uri="http://schemas.openxmlformats.org/drawingml/2006/table">
            <a:tbl>
              <a:tblPr firstRow="1" firstCol="1" bandRow="1"/>
              <a:tblGrid>
                <a:gridCol w="2453476">
                  <a:extLst>
                    <a:ext uri="{9D8B030D-6E8A-4147-A177-3AD203B41FA5}">
                      <a16:colId xmlns:a16="http://schemas.microsoft.com/office/drawing/2014/main" val="2968745460"/>
                    </a:ext>
                  </a:extLst>
                </a:gridCol>
                <a:gridCol w="775069">
                  <a:extLst>
                    <a:ext uri="{9D8B030D-6E8A-4147-A177-3AD203B41FA5}">
                      <a16:colId xmlns:a16="http://schemas.microsoft.com/office/drawing/2014/main" val="3026248117"/>
                    </a:ext>
                  </a:extLst>
                </a:gridCol>
                <a:gridCol w="919323">
                  <a:extLst>
                    <a:ext uri="{9D8B030D-6E8A-4147-A177-3AD203B41FA5}">
                      <a16:colId xmlns:a16="http://schemas.microsoft.com/office/drawing/2014/main" val="3445362040"/>
                    </a:ext>
                  </a:extLst>
                </a:gridCol>
                <a:gridCol w="3652337">
                  <a:extLst>
                    <a:ext uri="{9D8B030D-6E8A-4147-A177-3AD203B41FA5}">
                      <a16:colId xmlns:a16="http://schemas.microsoft.com/office/drawing/2014/main" val="3240912973"/>
                    </a:ext>
                  </a:extLst>
                </a:gridCol>
                <a:gridCol w="638614">
                  <a:extLst>
                    <a:ext uri="{9D8B030D-6E8A-4147-A177-3AD203B41FA5}">
                      <a16:colId xmlns:a16="http://schemas.microsoft.com/office/drawing/2014/main" val="3359600894"/>
                    </a:ext>
                  </a:extLst>
                </a:gridCol>
                <a:gridCol w="695146">
                  <a:extLst>
                    <a:ext uri="{9D8B030D-6E8A-4147-A177-3AD203B41FA5}">
                      <a16:colId xmlns:a16="http://schemas.microsoft.com/office/drawing/2014/main" val="1357316562"/>
                    </a:ext>
                  </a:extLst>
                </a:gridCol>
                <a:gridCol w="1771197">
                  <a:extLst>
                    <a:ext uri="{9D8B030D-6E8A-4147-A177-3AD203B41FA5}">
                      <a16:colId xmlns:a16="http://schemas.microsoft.com/office/drawing/2014/main" val="2568440151"/>
                    </a:ext>
                  </a:extLst>
                </a:gridCol>
              </a:tblGrid>
              <a:tr h="466473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aining-method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ate searched: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atabase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eywords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hits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luded in review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arch mode</a:t>
                      </a:r>
                      <a:endParaRPr lang="en-US" sz="1000" b="1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4249279"/>
                  </a:ext>
                </a:extLst>
              </a:tr>
              <a:tr h="466473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utoregulatory progressive resistance exercise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9.04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PORTDiscus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Autoregulatory progressive resistance exercise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Boolean/phr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6727267"/>
                  </a:ext>
                </a:extLst>
              </a:tr>
              <a:tr h="500961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ting of perceived exertion. Rating of perceived exertion with stop. Reps in reserve.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.04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PORTDiscu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Rating of perceived exertion” OR “reps in reserve” OR “RPE-stop” AND “1 repetition maximum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15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Boolean/phr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6477073"/>
                  </a:ext>
                </a:extLst>
              </a:tr>
              <a:tr h="466473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exible nonlinear periodization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.04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PORTDiscu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Flexible nonlinear periodization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Boolean/phr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557349"/>
                  </a:ext>
                </a:extLst>
              </a:tr>
              <a:tr h="696080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locity based resistance trainin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2.04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PORTDiscus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Velocity based resistance training” OR “velocity-based training” OR “velocity loss” AND “1 repetition maximum” AND “linear position transducer” OR “linear velocity transducer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Boolean/phr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0931683"/>
                  </a:ext>
                </a:extLst>
              </a:tr>
              <a:tr h="466473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utoregulatory progressive resistance exercise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9.05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ogle Schola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Autoregulatory progressive resistance exercise” AND “autoregulation” AND “1 repetition maximum”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3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find all word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842778"/>
                  </a:ext>
                </a:extLst>
              </a:tr>
              <a:tr h="500961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ting of perceived exertion. Rating of perceived exertion with stop. Reps in reserve.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.05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ogle Schola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Rating of perceived exertion” OR “reps in reserve” OR “RPE-stop” AND “1 repetition maximum” AND “autoregulation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84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find all words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5720379"/>
                  </a:ext>
                </a:extLst>
              </a:tr>
              <a:tr h="466473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exible nonlinear periodizatio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.05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ogle Schola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Flexible nonlinear periodization” AND “autoregulation” AND “1 repetition maximum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find all word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9702521"/>
                  </a:ext>
                </a:extLst>
              </a:tr>
              <a:tr h="696080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locity based resistance trainin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.06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oogle Schola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Velocity based resistance training” AND “autoregulation” AND “linear position transducer” OR “linear velocity transducer” AND “autoregulation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2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find all words, removed: patents AND quotes 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9360148"/>
                  </a:ext>
                </a:extLst>
              </a:tr>
              <a:tr h="466473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utoregulatory progressive resistance exerci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05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ubMe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Autoregulatory progressive resistance exercise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all field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7639364"/>
                  </a:ext>
                </a:extLst>
              </a:tr>
              <a:tr h="500961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ating of perceived exertion. Rating of perceived exertion with stop. Reps in reserve.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05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ubMe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Rating of perceived exertion” OR “reps in reserve” OR “RPE-stop” AND “1 repetition maximum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all field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7269974"/>
                  </a:ext>
                </a:extLst>
              </a:tr>
              <a:tr h="236867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lexible nonlinear periodizatio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.05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ubMe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Flexible nonlinear periodization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all field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4304028"/>
                  </a:ext>
                </a:extLst>
              </a:tr>
              <a:tr h="696080"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locity based resistance trainin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.05.20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ubMe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“Velocity based training” OR “velocity-based resistance training” OR “velocity loss” AND “linear position transducer” OR “linear velocity transducer”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vanced search, all fields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2044" marR="52044" marT="7228" marB="0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99135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61988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4</TotalTime>
  <Words>432</Words>
  <Application>Microsoft Office PowerPoint</Application>
  <PresentationFormat>Widescreen</PresentationFormat>
  <Paragraphs>91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4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sj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Stian Larsen</dc:creator>
  <cp:lastModifiedBy>Roland Johannes Wilhelmus van den van den Tillaar</cp:lastModifiedBy>
  <cp:revision>27</cp:revision>
  <dcterms:created xsi:type="dcterms:W3CDTF">2020-02-19T12:48:21Z</dcterms:created>
  <dcterms:modified xsi:type="dcterms:W3CDTF">2020-10-11T14:02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3b303ab-7198-40dd-8c74-47e8ccb3836e_Enabled">
    <vt:lpwstr>True</vt:lpwstr>
  </property>
  <property fmtid="{D5CDD505-2E9C-101B-9397-08002B2CF9AE}" pid="3" name="MSIP_Label_43b303ab-7198-40dd-8c74-47e8ccb3836e_SiteId">
    <vt:lpwstr>fed13d9f-21df-485d-909a-231f3c6d16f0</vt:lpwstr>
  </property>
  <property fmtid="{D5CDD505-2E9C-101B-9397-08002B2CF9AE}" pid="4" name="MSIP_Label_43b303ab-7198-40dd-8c74-47e8ccb3836e_Owner">
    <vt:lpwstr>roland.v.tillaar@nord.no</vt:lpwstr>
  </property>
  <property fmtid="{D5CDD505-2E9C-101B-9397-08002B2CF9AE}" pid="5" name="MSIP_Label_43b303ab-7198-40dd-8c74-47e8ccb3836e_SetDate">
    <vt:lpwstr>2020-10-11T14:02:22.2064972Z</vt:lpwstr>
  </property>
  <property fmtid="{D5CDD505-2E9C-101B-9397-08002B2CF9AE}" pid="6" name="MSIP_Label_43b303ab-7198-40dd-8c74-47e8ccb3836e_Name">
    <vt:lpwstr>Public</vt:lpwstr>
  </property>
  <property fmtid="{D5CDD505-2E9C-101B-9397-08002B2CF9AE}" pid="7" name="MSIP_Label_43b303ab-7198-40dd-8c74-47e8ccb3836e_Application">
    <vt:lpwstr>Microsoft Azure Information Protection</vt:lpwstr>
  </property>
  <property fmtid="{D5CDD505-2E9C-101B-9397-08002B2CF9AE}" pid="8" name="MSIP_Label_43b303ab-7198-40dd-8c74-47e8ccb3836e_Extended_MSFT_Method">
    <vt:lpwstr>Automatic</vt:lpwstr>
  </property>
  <property fmtid="{D5CDD505-2E9C-101B-9397-08002B2CF9AE}" pid="9" name="Sensitivity">
    <vt:lpwstr>Public</vt:lpwstr>
  </property>
</Properties>
</file>